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20" y="3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490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436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072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034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29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36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353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441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346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627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062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3A347-3352-4967-907A-8F335FDF82FC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2AFF94-F7CB-4EB2-B1B7-863D7F4CDC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810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.wmf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30200" y="-71611"/>
            <a:ext cx="11176000" cy="8864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/>
              <a:t>Reviewer #3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i="1" dirty="0" smtClean="0"/>
              <a:t>Figure </a:t>
            </a:r>
            <a:r>
              <a:rPr lang="en-US" sz="1400" i="1" dirty="0"/>
              <a:t>3 </a:t>
            </a:r>
            <a:r>
              <a:rPr lang="en-US" sz="1400" i="1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t </a:t>
            </a:r>
            <a:r>
              <a:rPr lang="en-US" sz="14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uld be appropriate to include the original full images (full gels, without contrast) of the membranes used for immunoblot analysis as a supplemental file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69485" y="972542"/>
            <a:ext cx="8989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Representative full images of the membranes after immunoblotting with specific antibodies </a:t>
            </a:r>
            <a:endParaRPr lang="en-US" b="1" dirty="0"/>
          </a:p>
        </p:txBody>
      </p:sp>
      <p:grpSp>
        <p:nvGrpSpPr>
          <p:cNvPr id="39" name="Group 38"/>
          <p:cNvGrpSpPr/>
          <p:nvPr/>
        </p:nvGrpSpPr>
        <p:grpSpPr>
          <a:xfrm>
            <a:off x="2151741" y="1651000"/>
            <a:ext cx="2280105" cy="3732102"/>
            <a:chOff x="2151741" y="1651000"/>
            <a:chExt cx="2280105" cy="3732102"/>
          </a:xfrm>
        </p:grpSpPr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51195690"/>
                </p:ext>
              </p:extLst>
            </p:nvPr>
          </p:nvGraphicFramePr>
          <p:xfrm>
            <a:off x="2870882" y="1971334"/>
            <a:ext cx="1539418" cy="30358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89" name="Image" r:id="rId3" imgW="1533600" imgH="3024000" progId="Photoshop.Image.11">
                    <p:embed/>
                  </p:oleObj>
                </mc:Choice>
                <mc:Fallback>
                  <p:oleObj name="Image" r:id="rId3" imgW="1533600" imgH="3024000" progId="Photoshop.Image.11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870882" y="1971334"/>
                          <a:ext cx="1539418" cy="3035808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3296586" y="5013770"/>
              <a:ext cx="6880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prstClr val="black"/>
                  </a:solidFill>
                </a:rPr>
                <a:t>DRP1</a:t>
              </a:r>
              <a:endParaRPr lang="en-US" dirty="0">
                <a:solidFill>
                  <a:prstClr val="black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151741" y="3124203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prstClr val="black"/>
                  </a:solidFill>
                </a:rPr>
                <a:t>80kDa</a:t>
              </a:r>
              <a:endParaRPr lang="en-US" sz="12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2672449" y="3287490"/>
              <a:ext cx="18288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2870200" y="1651000"/>
              <a:ext cx="15616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prstClr val="black"/>
                  </a:solidFill>
                </a:rPr>
                <a:t> H69     H82   H526</a:t>
              </a:r>
              <a:endParaRPr lang="en-US" sz="140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-76203" y="1651000"/>
            <a:ext cx="2259549" cy="3732102"/>
            <a:chOff x="-76203" y="1651000"/>
            <a:chExt cx="2259549" cy="3732102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2421" y="1966806"/>
              <a:ext cx="1550925" cy="303324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998359" y="5013770"/>
              <a:ext cx="7537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prstClr val="black"/>
                  </a:solidFill>
                </a:rPr>
                <a:t>MFN2</a:t>
              </a:r>
              <a:endParaRPr lang="en-US" dirty="0">
                <a:solidFill>
                  <a:prstClr val="black"/>
                </a:solidFill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>
              <a:off x="431802" y="2988129"/>
              <a:ext cx="18288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647700" y="1651000"/>
              <a:ext cx="1521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prstClr val="black"/>
                  </a:solidFill>
                </a:rPr>
                <a:t>H69      H82   H526</a:t>
              </a:r>
              <a:endParaRPr 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-76203" y="2824842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prstClr val="black"/>
                  </a:solidFill>
                </a:rPr>
                <a:t>86kDa</a:t>
              </a:r>
              <a:endParaRPr lang="en-US" sz="1200" b="1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4410300" y="1661839"/>
            <a:ext cx="2261325" cy="3746612"/>
            <a:chOff x="4410300" y="1661839"/>
            <a:chExt cx="2261325" cy="3746612"/>
          </a:xfrm>
        </p:grpSpPr>
        <p:graphicFrame>
          <p:nvGraphicFramePr>
            <p:cNvPr id="17" name="Object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25510347"/>
                </p:ext>
              </p:extLst>
            </p:nvPr>
          </p:nvGraphicFramePr>
          <p:xfrm>
            <a:off x="5117145" y="1977962"/>
            <a:ext cx="1554480" cy="30358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0" name="Image" r:id="rId6" imgW="1476000" imgH="2619000" progId="Photoshop.Image.11">
                    <p:embed/>
                  </p:oleObj>
                </mc:Choice>
                <mc:Fallback>
                  <p:oleObj name="Image" r:id="rId6" imgW="1476000" imgH="2619000" progId="Photoshop.Image.11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117145" y="1977962"/>
                          <a:ext cx="1554480" cy="3035808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>
              <a:off x="4410300" y="2839309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prstClr val="black"/>
                  </a:solidFill>
                </a:rPr>
                <a:t>91kDa</a:t>
              </a:r>
              <a:endParaRPr lang="en-US" sz="12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>
              <a:off x="4931004" y="2986267"/>
              <a:ext cx="18288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5535786" y="5039119"/>
              <a:ext cx="8915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prstClr val="black"/>
                  </a:solidFill>
                </a:rPr>
                <a:t>PGC-1</a:t>
              </a:r>
              <a:r>
                <a:rPr lang="el-GR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dirty="0">
                <a:solidFill>
                  <a:prstClr val="black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083387" y="1661839"/>
              <a:ext cx="15616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prstClr val="black"/>
                  </a:solidFill>
                </a:rPr>
                <a:t> H69     H82   H526</a:t>
              </a:r>
              <a:endParaRPr lang="en-US" sz="140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6834017" y="1661839"/>
            <a:ext cx="2292596" cy="2576402"/>
            <a:chOff x="6834017" y="1661839"/>
            <a:chExt cx="2292596" cy="2576402"/>
          </a:xfrm>
        </p:grpSpPr>
        <p:graphicFrame>
          <p:nvGraphicFramePr>
            <p:cNvPr id="22" name="Object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26817803"/>
                </p:ext>
              </p:extLst>
            </p:nvPr>
          </p:nvGraphicFramePr>
          <p:xfrm>
            <a:off x="7572133" y="1979342"/>
            <a:ext cx="1554480" cy="187257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1" name="Image" r:id="rId8" imgW="1303200" imgH="1569600" progId="Photoshop.Image.11">
                    <p:embed/>
                  </p:oleObj>
                </mc:Choice>
                <mc:Fallback>
                  <p:oleObj name="Image" r:id="rId8" imgW="1303200" imgH="1569600" progId="Photoshop.Image.11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572133" y="1979342"/>
                          <a:ext cx="1554480" cy="1872571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>
              <a:off x="6834017" y="2082758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prstClr val="black"/>
                  </a:solidFill>
                </a:rPr>
                <a:t>80kDa</a:t>
              </a:r>
              <a:endParaRPr lang="en-US" sz="1200" b="1" dirty="0">
                <a:solidFill>
                  <a:prstClr val="black"/>
                </a:solidFill>
              </a:endParaRPr>
            </a:p>
          </p:txBody>
        </p:sp>
        <p:cxnSp>
          <p:nvCxnSpPr>
            <p:cNvPr id="24" name="Straight Arrow Connector 23"/>
            <p:cNvCxnSpPr/>
            <p:nvPr/>
          </p:nvCxnSpPr>
          <p:spPr>
            <a:xfrm>
              <a:off x="7354725" y="2246045"/>
              <a:ext cx="18288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7954072" y="3868909"/>
              <a:ext cx="790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prstClr val="black"/>
                  </a:solidFill>
                </a:rPr>
                <a:t>TRAP1</a:t>
              </a:r>
              <a:endParaRPr lang="en-US" dirty="0">
                <a:solidFill>
                  <a:prstClr val="black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534336" y="1661839"/>
              <a:ext cx="15616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prstClr val="black"/>
                  </a:solidFill>
                </a:rPr>
                <a:t> H69     H82   H526</a:t>
              </a:r>
              <a:endParaRPr lang="en-US" sz="140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9300619" y="1662527"/>
            <a:ext cx="2260026" cy="2647152"/>
            <a:chOff x="9300619" y="1662527"/>
            <a:chExt cx="2260026" cy="2647152"/>
          </a:xfrm>
        </p:grpSpPr>
        <p:graphicFrame>
          <p:nvGraphicFramePr>
            <p:cNvPr id="27" name="Object 2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44493836"/>
                </p:ext>
              </p:extLst>
            </p:nvPr>
          </p:nvGraphicFramePr>
          <p:xfrm>
            <a:off x="10027120" y="1977962"/>
            <a:ext cx="1533525" cy="1947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2" name="Image" r:id="rId10" imgW="1533240" imgH="2599920" progId="Photoshop.Image.11">
                    <p:embed/>
                  </p:oleObj>
                </mc:Choice>
                <mc:Fallback>
                  <p:oleObj name="Image" r:id="rId10" imgW="1533240" imgH="2599920" progId="Photoshop.Image.11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0027120" y="1977962"/>
                          <a:ext cx="1533525" cy="1947925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TextBox 27"/>
            <p:cNvSpPr txBox="1"/>
            <p:nvPr/>
          </p:nvSpPr>
          <p:spPr>
            <a:xfrm>
              <a:off x="10540406" y="3940347"/>
              <a:ext cx="6238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prstClr val="black"/>
                  </a:solidFill>
                </a:rPr>
                <a:t>FIS 1</a:t>
              </a:r>
              <a:endParaRPr lang="en-US" dirty="0">
                <a:solidFill>
                  <a:prstClr val="black"/>
                </a:solidFill>
              </a:endParaRPr>
            </a:p>
          </p:txBody>
        </p:sp>
        <p:cxnSp>
          <p:nvCxnSpPr>
            <p:cNvPr id="29" name="Straight Arrow Connector 28"/>
            <p:cNvCxnSpPr/>
            <p:nvPr/>
          </p:nvCxnSpPr>
          <p:spPr>
            <a:xfrm>
              <a:off x="9804995" y="3193788"/>
              <a:ext cx="18288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9300619" y="3030500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prstClr val="black"/>
                  </a:solidFill>
                </a:rPr>
                <a:t>17kDa</a:t>
              </a:r>
              <a:endParaRPr lang="en-US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0011803" y="1662527"/>
              <a:ext cx="1441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prstClr val="black"/>
                  </a:solidFill>
                </a:rPr>
                <a:t> H69   H82   H526</a:t>
              </a:r>
              <a:endParaRPr lang="en-US" sz="1400" dirty="0">
                <a:solidFill>
                  <a:prstClr val="black"/>
                </a:solidFill>
              </a:endParaRP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6856096" y="4280235"/>
            <a:ext cx="2281741" cy="2599984"/>
            <a:chOff x="6856096" y="4280235"/>
            <a:chExt cx="2281741" cy="2599984"/>
          </a:xfrm>
        </p:grpSpPr>
        <p:graphicFrame>
          <p:nvGraphicFramePr>
            <p:cNvPr id="32" name="Object 3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0348475"/>
                </p:ext>
              </p:extLst>
            </p:nvPr>
          </p:nvGraphicFramePr>
          <p:xfrm>
            <a:off x="7572133" y="4592797"/>
            <a:ext cx="1554480" cy="19086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3" name="Image" r:id="rId12" imgW="1504440" imgH="1847520" progId="Photoshop.Image.11">
                    <p:embed/>
                  </p:oleObj>
                </mc:Choice>
                <mc:Fallback>
                  <p:oleObj name="Image" r:id="rId12" imgW="1504440" imgH="1847520" progId="Photoshop.Image.11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7572133" y="4592797"/>
                          <a:ext cx="1554480" cy="1908665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TextBox 32"/>
            <p:cNvSpPr txBox="1"/>
            <p:nvPr/>
          </p:nvSpPr>
          <p:spPr>
            <a:xfrm>
              <a:off x="7889052" y="6510887"/>
              <a:ext cx="1083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prstClr val="black"/>
                  </a:solidFill>
                </a:rPr>
                <a:t>Pan-Actin</a:t>
              </a:r>
              <a:endParaRPr lang="en-US" dirty="0">
                <a:solidFill>
                  <a:prstClr val="black"/>
                </a:solidFill>
              </a:endParaRPr>
            </a:p>
          </p:txBody>
        </p:sp>
        <p:cxnSp>
          <p:nvCxnSpPr>
            <p:cNvPr id="34" name="Straight Arrow Connector 33"/>
            <p:cNvCxnSpPr/>
            <p:nvPr/>
          </p:nvCxnSpPr>
          <p:spPr>
            <a:xfrm>
              <a:off x="7355022" y="4937012"/>
              <a:ext cx="18288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6856096" y="4795494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prstClr val="black"/>
                  </a:solidFill>
                </a:rPr>
                <a:t>42kDa</a:t>
              </a:r>
              <a:endParaRPr lang="en-US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7616267" y="4280235"/>
              <a:ext cx="1521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prstClr val="black"/>
                  </a:solidFill>
                </a:rPr>
                <a:t>H69     H82    H526</a:t>
              </a:r>
              <a:endParaRPr lang="en-US" sz="1400" dirty="0">
                <a:solidFill>
                  <a:prstClr val="black"/>
                </a:solidFill>
              </a:endParaRPr>
            </a:p>
          </p:txBody>
        </p:sp>
      </p:grpSp>
      <p:sp>
        <p:nvSpPr>
          <p:cNvPr id="37" name="Rectangle 36"/>
          <p:cNvSpPr/>
          <p:nvPr/>
        </p:nvSpPr>
        <p:spPr>
          <a:xfrm>
            <a:off x="998359" y="6059065"/>
            <a:ext cx="5213536" cy="592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ll images of the membranes after specific antibodies. TRAP1, FIS1 and pan-Actin membrane were cut before development, upper part was expose with other antibodies.  </a:t>
            </a:r>
          </a:p>
        </p:txBody>
      </p:sp>
    </p:spTree>
    <p:extLst>
      <p:ext uri="{BB962C8B-B14F-4D97-AF65-F5344CB8AC3E}">
        <p14:creationId xmlns:p14="http://schemas.microsoft.com/office/powerpoint/2010/main" val="202717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115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Office Theme</vt:lpstr>
      <vt:lpstr>Imag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zapoiazova, Tamara</dc:creator>
  <cp:lastModifiedBy>Mirzapoiazova, Tamara</cp:lastModifiedBy>
  <cp:revision>13</cp:revision>
  <dcterms:created xsi:type="dcterms:W3CDTF">2019-06-23T22:46:58Z</dcterms:created>
  <dcterms:modified xsi:type="dcterms:W3CDTF">2019-06-27T05:20:46Z</dcterms:modified>
</cp:coreProperties>
</file>